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3300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97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45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499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13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259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899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388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059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759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862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7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603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-1418384" y="2534379"/>
            <a:ext cx="8802978" cy="4292784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 3"/>
          <p:cNvSpPr/>
          <p:nvPr/>
        </p:nvSpPr>
        <p:spPr>
          <a:xfrm rot="16200000">
            <a:off x="1688904" y="3935832"/>
            <a:ext cx="856895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PIONs </a:t>
            </a:r>
            <a:r>
              <a:rPr lang="en-US" sz="1200" b="1" dirty="0"/>
              <a:t>with/without a plasma protein corona do not trigger pro-inflammatory TNF-α secretion. </a:t>
            </a:r>
            <a:r>
              <a:rPr lang="en-US" sz="1200" dirty="0"/>
              <a:t>Human monocyte-derived macrophages were exposed for 2 h (A, D), 6 h (B, E) or 24 h (C, F) to the indicated doses (µL/mL) of CSNP or CSNP + protein corona (A-C), or to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or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+ protein corona (D-F). Cytokine release was assessed using ELISA. LPS was used as positive control. Results are presented as TNF-α release (</a:t>
            </a:r>
            <a:r>
              <a:rPr lang="en-US" sz="1200" dirty="0" err="1"/>
              <a:t>pg</a:t>
            </a:r>
            <a:r>
              <a:rPr lang="en-US" sz="1200" dirty="0"/>
              <a:t>/ml) (mean values ± S.D.) from three independent experiments using cells obtained from healthy blood donors. Statistical analysis was performed using </a:t>
            </a:r>
            <a:r>
              <a:rPr lang="en-US" sz="1200" dirty="0" err="1"/>
              <a:t>Tukey</a:t>
            </a:r>
            <a:r>
              <a:rPr lang="en-US" sz="1200" dirty="0"/>
              <a:t> post-hoc test following one way ANOVA (***p&lt;0.001)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98716" y="384458"/>
            <a:ext cx="8700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2_Fig.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35495757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</TotalTime>
  <Words>13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arolinska Institutet, IM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deel, Bengt</dc:creator>
  <cp:lastModifiedBy>Fadeel, Bengt </cp:lastModifiedBy>
  <cp:revision>14</cp:revision>
  <cp:lastPrinted>2014-07-10T14:18:30Z</cp:lastPrinted>
  <dcterms:created xsi:type="dcterms:W3CDTF">2014-07-07T17:13:11Z</dcterms:created>
  <dcterms:modified xsi:type="dcterms:W3CDTF">2015-09-05T12:21:17Z</dcterms:modified>
</cp:coreProperties>
</file>